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3"/>
  </p:notesMasterIdLst>
  <p:sldIdLst>
    <p:sldId id="518" r:id="rId2"/>
  </p:sldIdLst>
  <p:sldSz cx="6858000" cy="9144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588" autoAdjust="0"/>
    <p:restoredTop sz="94660"/>
  </p:normalViewPr>
  <p:slideViewPr>
    <p:cSldViewPr snapToGrid="0">
      <p:cViewPr varScale="1">
        <p:scale>
          <a:sx n="86" d="100"/>
          <a:sy n="86" d="100"/>
        </p:scale>
        <p:origin x="324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1668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51AB1DDD-B0DF-47D9-86C6-6D8C5BD56A60}" type="datetimeFigureOut">
              <a:rPr lang="en-US" smtClean="0"/>
              <a:t>5/4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28863" y="1162050"/>
            <a:ext cx="23526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F374F08C-DBF4-4895-B2E2-F73ADCA483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92948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57951-CE25-4057-BF31-7F8A9C4A52E8}" type="datetimeFigureOut">
              <a:rPr lang="en-US" smtClean="0"/>
              <a:t>5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B3C35-D21C-47E0-A231-DBE39F70F6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66051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57951-CE25-4057-BF31-7F8A9C4A52E8}" type="datetimeFigureOut">
              <a:rPr lang="en-US" smtClean="0"/>
              <a:t>5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B3C35-D21C-47E0-A231-DBE39F70F6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89086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57951-CE25-4057-BF31-7F8A9C4A52E8}" type="datetimeFigureOut">
              <a:rPr lang="en-US" smtClean="0"/>
              <a:t>5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B3C35-D21C-47E0-A231-DBE39F70F6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34622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57951-CE25-4057-BF31-7F8A9C4A52E8}" type="datetimeFigureOut">
              <a:rPr lang="en-US" smtClean="0"/>
              <a:t>5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B3C35-D21C-47E0-A231-DBE39F70F6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23084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57951-CE25-4057-BF31-7F8A9C4A52E8}" type="datetimeFigureOut">
              <a:rPr lang="en-US" smtClean="0"/>
              <a:t>5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B3C35-D21C-47E0-A231-DBE39F70F6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54987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57951-CE25-4057-BF31-7F8A9C4A52E8}" type="datetimeFigureOut">
              <a:rPr lang="en-US" smtClean="0"/>
              <a:t>5/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B3C35-D21C-47E0-A231-DBE39F70F6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2260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57951-CE25-4057-BF31-7F8A9C4A52E8}" type="datetimeFigureOut">
              <a:rPr lang="en-US" smtClean="0"/>
              <a:t>5/4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B3C35-D21C-47E0-A231-DBE39F70F6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06772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57951-CE25-4057-BF31-7F8A9C4A52E8}" type="datetimeFigureOut">
              <a:rPr lang="en-US" smtClean="0"/>
              <a:t>5/4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B3C35-D21C-47E0-A231-DBE39F70F6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630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57951-CE25-4057-BF31-7F8A9C4A52E8}" type="datetimeFigureOut">
              <a:rPr lang="en-US" smtClean="0"/>
              <a:t>5/4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B3C35-D21C-47E0-A231-DBE39F70F6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37378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57951-CE25-4057-BF31-7F8A9C4A52E8}" type="datetimeFigureOut">
              <a:rPr lang="en-US" smtClean="0"/>
              <a:t>5/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B3C35-D21C-47E0-A231-DBE39F70F6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00821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57951-CE25-4057-BF31-7F8A9C4A52E8}" type="datetimeFigureOut">
              <a:rPr lang="en-US" smtClean="0"/>
              <a:t>5/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B3C35-D21C-47E0-A231-DBE39F70F6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89064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057951-CE25-4057-BF31-7F8A9C4A52E8}" type="datetimeFigureOut">
              <a:rPr lang="en-US" smtClean="0"/>
              <a:t>5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AB3C35-D21C-47E0-A231-DBE39F70F6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38855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8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17" Type="http://schemas.openxmlformats.org/officeDocument/2006/relationships/oleObject" Target="../embeddings/oleObject8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7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7A8F9B9B-BCFB-481B-B14A-8E387C8FE8F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5742811"/>
              </p:ext>
            </p:extLst>
          </p:nvPr>
        </p:nvGraphicFramePr>
        <p:xfrm>
          <a:off x="868681" y="767653"/>
          <a:ext cx="2461124" cy="1803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90" name="Prism 9" r:id="rId3" imgW="4058369" imgH="2973072" progId="Prism9.Document">
                  <p:embed/>
                </p:oleObj>
              </mc:Choice>
              <mc:Fallback>
                <p:oleObj name="Prism 9" r:id="rId3" imgW="4058369" imgH="2973072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68681" y="767653"/>
                        <a:ext cx="2461124" cy="18034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333BFF5F-FA13-4375-84FF-A74C13EB928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36252510"/>
              </p:ext>
            </p:extLst>
          </p:nvPr>
        </p:nvGraphicFramePr>
        <p:xfrm>
          <a:off x="868680" y="2623965"/>
          <a:ext cx="2461124" cy="18034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91" name="Prism 9" r:id="rId5" imgW="4058369" imgH="2973072" progId="Prism9.Document">
                  <p:embed/>
                </p:oleObj>
              </mc:Choice>
              <mc:Fallback>
                <p:oleObj name="Prism 9" r:id="rId5" imgW="4058369" imgH="2973072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868680" y="2623965"/>
                        <a:ext cx="2461124" cy="180347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4DF2CBD9-9FE4-4292-B4ED-99B99249553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0799600"/>
              </p:ext>
            </p:extLst>
          </p:nvPr>
        </p:nvGraphicFramePr>
        <p:xfrm>
          <a:off x="868681" y="4471641"/>
          <a:ext cx="2461123" cy="1803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92" name="Prism 9" r:id="rId7" imgW="4058369" imgH="2973072" progId="Prism9.Document">
                  <p:embed/>
                </p:oleObj>
              </mc:Choice>
              <mc:Fallback>
                <p:oleObj name="Prism 9" r:id="rId7" imgW="4058369" imgH="2973072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868681" y="4471641"/>
                        <a:ext cx="2461123" cy="18034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D8D9DC8F-3072-4B4E-AD1E-2FFB56875CC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64820081"/>
              </p:ext>
            </p:extLst>
          </p:nvPr>
        </p:nvGraphicFramePr>
        <p:xfrm>
          <a:off x="868680" y="6352765"/>
          <a:ext cx="2461124" cy="18034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93" name="Prism 9" r:id="rId9" imgW="4058369" imgH="2973072" progId="Prism9.Document">
                  <p:embed/>
                </p:oleObj>
              </mc:Choice>
              <mc:Fallback>
                <p:oleObj name="Prism 9" r:id="rId9" imgW="4058369" imgH="2973072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868680" y="6352765"/>
                        <a:ext cx="2461124" cy="180347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26BD689D-1796-4941-B80A-BB1799B3A37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01771303"/>
              </p:ext>
            </p:extLst>
          </p:nvPr>
        </p:nvGraphicFramePr>
        <p:xfrm>
          <a:off x="3329804" y="767653"/>
          <a:ext cx="2791392" cy="18034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94" name="Prism 9" r:id="rId11" imgW="4602534" imgH="2973072" progId="Prism9.Document">
                  <p:embed/>
                </p:oleObj>
              </mc:Choice>
              <mc:Fallback>
                <p:oleObj name="Prism 9" r:id="rId11" imgW="4602534" imgH="2973072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329804" y="767653"/>
                        <a:ext cx="2791392" cy="180347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8C5785A3-3B3C-4E0E-8277-AA8F7331F6E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33617384"/>
              </p:ext>
            </p:extLst>
          </p:nvPr>
        </p:nvGraphicFramePr>
        <p:xfrm>
          <a:off x="3350075" y="2565543"/>
          <a:ext cx="2808723" cy="1803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95" name="Prism 9" r:id="rId13" imgW="4630265" imgH="2973072" progId="Prism9.Document">
                  <p:embed/>
                </p:oleObj>
              </mc:Choice>
              <mc:Fallback>
                <p:oleObj name="Prism 9" r:id="rId13" imgW="4630265" imgH="2973072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350075" y="2565543"/>
                        <a:ext cx="2808723" cy="18034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6C91AE84-357E-459E-8FFF-1210829E100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92408980"/>
              </p:ext>
            </p:extLst>
          </p:nvPr>
        </p:nvGraphicFramePr>
        <p:xfrm>
          <a:off x="3344446" y="4482274"/>
          <a:ext cx="2802945" cy="1803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96" name="Prism 9" r:id="rId15" imgW="4620901" imgH="2973072" progId="Prism9.Document">
                  <p:embed/>
                </p:oleObj>
              </mc:Choice>
              <mc:Fallback>
                <p:oleObj name="Prism 9" r:id="rId15" imgW="4620901" imgH="2973072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3344446" y="4482274"/>
                        <a:ext cx="2802945" cy="18034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7901E6AA-DD9E-4EF7-B3E1-0ECCBDF9D18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9114950"/>
              </p:ext>
            </p:extLst>
          </p:nvPr>
        </p:nvGraphicFramePr>
        <p:xfrm>
          <a:off x="3318251" y="6352765"/>
          <a:ext cx="2802945" cy="1803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97" name="Prism 9" r:id="rId17" imgW="4620901" imgH="2973072" progId="Prism9.Document">
                  <p:embed/>
                </p:oleObj>
              </mc:Choice>
              <mc:Fallback>
                <p:oleObj name="Prism 9" r:id="rId17" imgW="4620901" imgH="2973072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3318251" y="6352765"/>
                        <a:ext cx="2802945" cy="18034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TextBox 11">
            <a:extLst>
              <a:ext uri="{FF2B5EF4-FFF2-40B4-BE49-F238E27FC236}">
                <a16:creationId xmlns:a16="http://schemas.microsoft.com/office/drawing/2014/main" id="{05F16817-A5C4-4BA5-9F47-E72E7A27C36C}"/>
              </a:ext>
            </a:extLst>
          </p:cNvPr>
          <p:cNvSpPr txBox="1"/>
          <p:nvPr/>
        </p:nvSpPr>
        <p:spPr>
          <a:xfrm>
            <a:off x="2884174" y="160124"/>
            <a:ext cx="17251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4140ED5-5841-47DE-8AB7-D7337C3E36FA}"/>
              </a:ext>
            </a:extLst>
          </p:cNvPr>
          <p:cNvSpPr txBox="1"/>
          <p:nvPr/>
        </p:nvSpPr>
        <p:spPr>
          <a:xfrm>
            <a:off x="866353" y="702910"/>
            <a:ext cx="4586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A2E1C48-98A6-493A-B5DB-52255B63437E}"/>
              </a:ext>
            </a:extLst>
          </p:cNvPr>
          <p:cNvSpPr txBox="1"/>
          <p:nvPr/>
        </p:nvSpPr>
        <p:spPr>
          <a:xfrm>
            <a:off x="889694" y="2499968"/>
            <a:ext cx="4586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E499A3C-40E5-42C7-851D-4892C6331F11}"/>
              </a:ext>
            </a:extLst>
          </p:cNvPr>
          <p:cNvSpPr txBox="1"/>
          <p:nvPr/>
        </p:nvSpPr>
        <p:spPr>
          <a:xfrm>
            <a:off x="878027" y="4424537"/>
            <a:ext cx="4586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0D41039-B18F-4499-AEC3-2AB1B20A2514}"/>
              </a:ext>
            </a:extLst>
          </p:cNvPr>
          <p:cNvSpPr txBox="1"/>
          <p:nvPr/>
        </p:nvSpPr>
        <p:spPr>
          <a:xfrm>
            <a:off x="879066" y="6320303"/>
            <a:ext cx="4586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F2F597D-3A1E-4FD2-BDE5-E6BFCEEA736B}"/>
              </a:ext>
            </a:extLst>
          </p:cNvPr>
          <p:cNvSpPr txBox="1"/>
          <p:nvPr/>
        </p:nvSpPr>
        <p:spPr>
          <a:xfrm>
            <a:off x="3290498" y="707148"/>
            <a:ext cx="4586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62680F8-A72E-41C4-8897-F67DFA0F6F49}"/>
              </a:ext>
            </a:extLst>
          </p:cNvPr>
          <p:cNvSpPr txBox="1"/>
          <p:nvPr/>
        </p:nvSpPr>
        <p:spPr>
          <a:xfrm>
            <a:off x="3313837" y="2528061"/>
            <a:ext cx="4586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72BDBDA-3CA4-4C99-BF27-92C8D4E68CE0}"/>
              </a:ext>
            </a:extLst>
          </p:cNvPr>
          <p:cNvSpPr txBox="1"/>
          <p:nvPr/>
        </p:nvSpPr>
        <p:spPr>
          <a:xfrm>
            <a:off x="3270369" y="4428779"/>
            <a:ext cx="4586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G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0598DD3-1F4E-407C-B1B3-8C505C9F7F19}"/>
              </a:ext>
            </a:extLst>
          </p:cNvPr>
          <p:cNvSpPr txBox="1"/>
          <p:nvPr/>
        </p:nvSpPr>
        <p:spPr>
          <a:xfrm>
            <a:off x="3263453" y="6324537"/>
            <a:ext cx="4586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H)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98DC192C-98A2-43CF-86FC-E29AF74DC4F5}"/>
              </a:ext>
            </a:extLst>
          </p:cNvPr>
          <p:cNvSpPr/>
          <p:nvPr/>
        </p:nvSpPr>
        <p:spPr>
          <a:xfrm>
            <a:off x="866353" y="8195240"/>
            <a:ext cx="5411784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</a:rPr>
              <a:t>Supplementary Figure S2. Tumor burden of individual mouse received Colo205 cells.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</a:rPr>
              <a:t>Tumor volumes on the left (A-D) and the right (E-H) flanks were measured at different days after the start of treatments.</a:t>
            </a:r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28799597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244</TotalTime>
  <Words>58</Words>
  <Application>Microsoft Office PowerPoint</Application>
  <PresentationFormat>On-screen Show (4:3)</PresentationFormat>
  <Paragraphs>10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9</vt:lpstr>
      <vt:lpstr>PowerPoint Presentation</vt:lpstr>
    </vt:vector>
  </TitlesOfParts>
  <Company>Arizona State University OKE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smudur Rahman</dc:creator>
  <cp:lastModifiedBy>Masmudur Rahman</cp:lastModifiedBy>
  <cp:revision>400</cp:revision>
  <cp:lastPrinted>2022-07-28T21:46:33Z</cp:lastPrinted>
  <dcterms:created xsi:type="dcterms:W3CDTF">2018-11-27T16:44:45Z</dcterms:created>
  <dcterms:modified xsi:type="dcterms:W3CDTF">2023-05-05T00:10:55Z</dcterms:modified>
</cp:coreProperties>
</file>